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174" autoAdjust="0"/>
  </p:normalViewPr>
  <p:slideViewPr>
    <p:cSldViewPr>
      <p:cViewPr varScale="1">
        <p:scale>
          <a:sx n="71" d="100"/>
          <a:sy n="71" d="100"/>
        </p:scale>
        <p:origin x="750" y="33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AE3818-F909-4F05-9251-7AF3086E806D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D1924C-9571-46CD-A751-C36EE367FB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296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3: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thly hospitalization (A) and PED attendance (B) incidence rates for Diseases of the Respiratory System, with line trend from ITS regression analysis. Abbreviations: PC=Pre-COVID19 phase; SC=School Closure phase; MM=Mitigation Measures phase; PE=Post-Emergency phase.</a:t>
            </a:r>
            <a:endParaRPr lang="it-IT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D1924C-9571-46CD-A751-C36EE367FB12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4550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4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0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7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1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4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28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793075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1799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5386387" y="396703"/>
            <a:ext cx="1671638" cy="845220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71476" y="396703"/>
            <a:ext cx="4900613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3344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4353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52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04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05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40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761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112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464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2815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923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71476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771901" y="2311402"/>
            <a:ext cx="3286125" cy="6537502"/>
          </a:xfrm>
        </p:spPr>
        <p:txBody>
          <a:bodyPr/>
          <a:lstStyle>
            <a:lvl1pPr>
              <a:defRPr sz="4043"/>
            </a:lvl1pPr>
            <a:lvl2pPr>
              <a:defRPr sz="3468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9856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3468" b="1"/>
            </a:lvl1pPr>
            <a:lvl2pPr marL="660352" indent="0">
              <a:buNone/>
              <a:defRPr sz="2889" b="1"/>
            </a:lvl2pPr>
            <a:lvl3pPr marL="1320704" indent="0">
              <a:buNone/>
              <a:defRPr sz="2600" b="1"/>
            </a:lvl3pPr>
            <a:lvl4pPr marL="1981057" indent="0">
              <a:buNone/>
              <a:defRPr sz="2311" b="1"/>
            </a:lvl4pPr>
            <a:lvl5pPr marL="2641408" indent="0">
              <a:buNone/>
              <a:defRPr sz="2311" b="1"/>
            </a:lvl5pPr>
            <a:lvl6pPr marL="3301761" indent="0">
              <a:buNone/>
              <a:defRPr sz="2311" b="1"/>
            </a:lvl6pPr>
            <a:lvl7pPr marL="3962112" indent="0">
              <a:buNone/>
              <a:defRPr sz="2311" b="1"/>
            </a:lvl7pPr>
            <a:lvl8pPr marL="4622464" indent="0">
              <a:buNone/>
              <a:defRPr sz="2311" b="1"/>
            </a:lvl8pPr>
            <a:lvl9pPr marL="5282815" indent="0">
              <a:buNone/>
              <a:defRPr sz="2311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3468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9746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720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08744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9"/>
            <a:ext cx="3833812" cy="8454497"/>
          </a:xfrm>
        </p:spPr>
        <p:txBody>
          <a:bodyPr/>
          <a:lstStyle>
            <a:lvl1pPr>
              <a:defRPr sz="4621"/>
            </a:lvl1pPr>
            <a:lvl2pPr>
              <a:defRPr sz="4043"/>
            </a:lvl2pPr>
            <a:lvl3pPr>
              <a:defRPr sz="3468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6452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1"/>
            </a:lvl1pPr>
            <a:lvl2pPr marL="660352" indent="0">
              <a:buNone/>
              <a:defRPr sz="4043"/>
            </a:lvl2pPr>
            <a:lvl3pPr marL="1320704" indent="0">
              <a:buNone/>
              <a:defRPr sz="3468"/>
            </a:lvl3pPr>
            <a:lvl4pPr marL="1981057" indent="0">
              <a:buNone/>
              <a:defRPr sz="2889"/>
            </a:lvl4pPr>
            <a:lvl5pPr marL="2641408" indent="0">
              <a:buNone/>
              <a:defRPr sz="2889"/>
            </a:lvl5pPr>
            <a:lvl6pPr marL="3301761" indent="0">
              <a:buNone/>
              <a:defRPr sz="2889"/>
            </a:lvl6pPr>
            <a:lvl7pPr marL="3962112" indent="0">
              <a:buNone/>
              <a:defRPr sz="2889"/>
            </a:lvl7pPr>
            <a:lvl8pPr marL="4622464" indent="0">
              <a:buNone/>
              <a:defRPr sz="2889"/>
            </a:lvl8pPr>
            <a:lvl9pPr marL="5282815" indent="0">
              <a:buNone/>
              <a:defRPr sz="2889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52" indent="0">
              <a:buNone/>
              <a:defRPr sz="1733"/>
            </a:lvl2pPr>
            <a:lvl3pPr marL="1320704" indent="0">
              <a:buNone/>
              <a:defRPr sz="1444"/>
            </a:lvl3pPr>
            <a:lvl4pPr marL="1981057" indent="0">
              <a:buNone/>
              <a:defRPr sz="1300"/>
            </a:lvl4pPr>
            <a:lvl5pPr marL="2641408" indent="0">
              <a:buNone/>
              <a:defRPr sz="1300"/>
            </a:lvl5pPr>
            <a:lvl6pPr marL="3301761" indent="0">
              <a:buNone/>
              <a:defRPr sz="1300"/>
            </a:lvl6pPr>
            <a:lvl7pPr marL="3962112" indent="0">
              <a:buNone/>
              <a:defRPr sz="1300"/>
            </a:lvl7pPr>
            <a:lvl8pPr marL="4622464" indent="0">
              <a:buNone/>
              <a:defRPr sz="1300"/>
            </a:lvl8pPr>
            <a:lvl9pPr marL="5282815" indent="0">
              <a:buNone/>
              <a:defRPr sz="13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92260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CF551D-22D2-4E11-BFA4-9CB064FED3D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8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8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EA613-05B9-495B-B4B0-0BFC3D716C6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95947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320704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65" indent="-495265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4621" kern="1200">
          <a:solidFill>
            <a:schemeClr val="tx1"/>
          </a:solidFill>
          <a:latin typeface="+mn-lt"/>
          <a:ea typeface="+mn-ea"/>
          <a:cs typeface="+mn-cs"/>
        </a:defRPr>
      </a:lvl1pPr>
      <a:lvl2pPr marL="1073071" indent="-412720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4043" kern="1200">
          <a:solidFill>
            <a:schemeClr val="tx1"/>
          </a:solidFill>
          <a:latin typeface="+mn-lt"/>
          <a:ea typeface="+mn-ea"/>
          <a:cs typeface="+mn-cs"/>
        </a:defRPr>
      </a:lvl2pPr>
      <a:lvl3pPr marL="1650880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3468" kern="1200">
          <a:solidFill>
            <a:schemeClr val="tx1"/>
          </a:solidFill>
          <a:latin typeface="+mn-lt"/>
          <a:ea typeface="+mn-ea"/>
          <a:cs typeface="+mn-cs"/>
        </a:defRPr>
      </a:lvl3pPr>
      <a:lvl4pPr marL="231123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584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193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287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641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2992" indent="-330177" algn="l" defTabSz="1320704" rtl="0" eaLnBrk="1" latinLnBrk="0" hangingPunct="1">
        <a:spcBef>
          <a:spcPct val="20000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5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0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057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408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761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112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464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2815" algn="l" defTabSz="1320704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0" y="-13811"/>
            <a:ext cx="6858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/>
              <a:t>Supplementary Figure S3: </a:t>
            </a:r>
            <a:r>
              <a:rPr lang="en-GB" sz="1200" dirty="0"/>
              <a:t>Monthly hospitalization (A) and PED attendance (B) incidence rates for Diseases of the Respiratory System, with line trend from ITS regression analysis. Abbreviations: PC=Pre-COVID19 phase; SC=School Closure phase; MM=Mitigation Measures </a:t>
            </a:r>
            <a:r>
              <a:rPr lang="en-GB" sz="1200" dirty="0" smtClean="0"/>
              <a:t>phase</a:t>
            </a:r>
            <a:endParaRPr lang="it-IT" sz="1200" dirty="0"/>
          </a:p>
        </p:txBody>
      </p:sp>
      <p:grpSp>
        <p:nvGrpSpPr>
          <p:cNvPr id="10" name="Gruppo 9"/>
          <p:cNvGrpSpPr/>
          <p:nvPr/>
        </p:nvGrpSpPr>
        <p:grpSpPr>
          <a:xfrm>
            <a:off x="218055" y="1123114"/>
            <a:ext cx="6451305" cy="4045910"/>
            <a:chOff x="-3680113" y="979098"/>
            <a:chExt cx="7229853" cy="4389950"/>
          </a:xfrm>
        </p:grpSpPr>
        <p:pic>
          <p:nvPicPr>
            <p:cNvPr id="9" name="Immagine 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3680113" y="979098"/>
              <a:ext cx="7229853" cy="4389950"/>
            </a:xfrm>
            <a:prstGeom prst="rect">
              <a:avLst/>
            </a:prstGeom>
          </p:spPr>
        </p:pic>
        <p:grpSp>
          <p:nvGrpSpPr>
            <p:cNvPr id="14" name="Gruppo 13"/>
            <p:cNvGrpSpPr/>
            <p:nvPr/>
          </p:nvGrpSpPr>
          <p:grpSpPr>
            <a:xfrm>
              <a:off x="-2677598" y="4527754"/>
              <a:ext cx="5960347" cy="279394"/>
              <a:chOff x="725355" y="3134605"/>
              <a:chExt cx="4126394" cy="193427"/>
            </a:xfrm>
          </p:grpSpPr>
          <p:grpSp>
            <p:nvGrpSpPr>
              <p:cNvPr id="6" name="Gruppo 5"/>
              <p:cNvGrpSpPr/>
              <p:nvPr/>
            </p:nvGrpSpPr>
            <p:grpSpPr>
              <a:xfrm>
                <a:off x="725355" y="3134605"/>
                <a:ext cx="2025510" cy="187064"/>
                <a:chOff x="632520" y="3138693"/>
                <a:chExt cx="2082860" cy="187064"/>
              </a:xfrm>
            </p:grpSpPr>
            <p:sp>
              <p:nvSpPr>
                <p:cNvPr id="1614" name="Rettangolo 1613"/>
                <p:cNvSpPr/>
                <p:nvPr/>
              </p:nvSpPr>
              <p:spPr>
                <a:xfrm>
                  <a:off x="1476065" y="3138693"/>
                  <a:ext cx="321909" cy="18706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156" dirty="0"/>
                    <a:t>PC</a:t>
                  </a:r>
                  <a:endParaRPr lang="it-IT" sz="1156" dirty="0"/>
                </a:p>
              </p:txBody>
            </p:sp>
            <p:cxnSp>
              <p:nvCxnSpPr>
                <p:cNvPr id="1617" name="Connettore 2 1616"/>
                <p:cNvCxnSpPr/>
                <p:nvPr/>
              </p:nvCxnSpPr>
              <p:spPr>
                <a:xfrm>
                  <a:off x="1831523" y="3264941"/>
                  <a:ext cx="883857" cy="90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18" name="Connettore 2 1617"/>
                <p:cNvCxnSpPr/>
                <p:nvPr/>
              </p:nvCxnSpPr>
              <p:spPr>
                <a:xfrm flipH="1">
                  <a:off x="632520" y="3264941"/>
                  <a:ext cx="832288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" name="Gruppo 6"/>
              <p:cNvGrpSpPr/>
              <p:nvPr/>
            </p:nvGrpSpPr>
            <p:grpSpPr>
              <a:xfrm>
                <a:off x="2802278" y="3138686"/>
                <a:ext cx="376593" cy="187064"/>
                <a:chOff x="2753684" y="3141541"/>
                <a:chExt cx="376593" cy="187064"/>
              </a:xfrm>
            </p:grpSpPr>
            <p:sp>
              <p:nvSpPr>
                <p:cNvPr id="1615" name="Rettangolo 1614"/>
                <p:cNvSpPr/>
                <p:nvPr/>
              </p:nvSpPr>
              <p:spPr>
                <a:xfrm>
                  <a:off x="2778783" y="3141541"/>
                  <a:ext cx="318107" cy="18706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156" dirty="0"/>
                    <a:t>SC</a:t>
                  </a:r>
                  <a:endParaRPr lang="it-IT" sz="1156" dirty="0"/>
                </a:p>
              </p:txBody>
            </p:sp>
            <p:cxnSp>
              <p:nvCxnSpPr>
                <p:cNvPr id="1619" name="Connettore 2 1618"/>
                <p:cNvCxnSpPr/>
                <p:nvPr/>
              </p:nvCxnSpPr>
              <p:spPr>
                <a:xfrm>
                  <a:off x="3005384" y="3264941"/>
                  <a:ext cx="124893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0" name="Connettore 2 1619"/>
                <p:cNvCxnSpPr/>
                <p:nvPr/>
              </p:nvCxnSpPr>
              <p:spPr>
                <a:xfrm flipH="1">
                  <a:off x="2753684" y="3264942"/>
                  <a:ext cx="99840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" name="Gruppo 7"/>
              <p:cNvGrpSpPr/>
              <p:nvPr/>
            </p:nvGrpSpPr>
            <p:grpSpPr>
              <a:xfrm>
                <a:off x="3215743" y="3140968"/>
                <a:ext cx="983608" cy="187064"/>
                <a:chOff x="3197546" y="3138693"/>
                <a:chExt cx="1611438" cy="187064"/>
              </a:xfrm>
            </p:grpSpPr>
            <p:sp>
              <p:nvSpPr>
                <p:cNvPr id="1616" name="Rettangolo 1615"/>
                <p:cNvSpPr/>
                <p:nvPr/>
              </p:nvSpPr>
              <p:spPr>
                <a:xfrm>
                  <a:off x="3645277" y="3138693"/>
                  <a:ext cx="647899" cy="18706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156" dirty="0"/>
                    <a:t>MM</a:t>
                  </a:r>
                  <a:endParaRPr lang="it-IT" sz="1156" dirty="0"/>
                </a:p>
              </p:txBody>
            </p:sp>
            <p:cxnSp>
              <p:nvCxnSpPr>
                <p:cNvPr id="1621" name="Connettore 2 1620"/>
                <p:cNvCxnSpPr/>
                <p:nvPr/>
              </p:nvCxnSpPr>
              <p:spPr>
                <a:xfrm>
                  <a:off x="4185971" y="3265846"/>
                  <a:ext cx="623013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22" name="Connettore 2 1621"/>
                <p:cNvCxnSpPr/>
                <p:nvPr/>
              </p:nvCxnSpPr>
              <p:spPr>
                <a:xfrm flipH="1">
                  <a:off x="3197546" y="3262086"/>
                  <a:ext cx="569182" cy="376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8" name="Gruppo 57"/>
              <p:cNvGrpSpPr/>
              <p:nvPr/>
            </p:nvGrpSpPr>
            <p:grpSpPr>
              <a:xfrm>
                <a:off x="4244808" y="3140968"/>
                <a:ext cx="606941" cy="187064"/>
                <a:chOff x="2753684" y="3141548"/>
                <a:chExt cx="376593" cy="187064"/>
              </a:xfrm>
            </p:grpSpPr>
            <p:sp>
              <p:nvSpPr>
                <p:cNvPr id="59" name="Rettangolo 58"/>
                <p:cNvSpPr/>
                <p:nvPr/>
              </p:nvSpPr>
              <p:spPr>
                <a:xfrm>
                  <a:off x="2782927" y="3141548"/>
                  <a:ext cx="318107" cy="187064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156" dirty="0"/>
                    <a:t>PE</a:t>
                  </a:r>
                  <a:endParaRPr lang="it-IT" sz="1156" dirty="0"/>
                </a:p>
              </p:txBody>
            </p:sp>
            <p:cxnSp>
              <p:nvCxnSpPr>
                <p:cNvPr id="60" name="Connettore 2 59"/>
                <p:cNvCxnSpPr/>
                <p:nvPr/>
              </p:nvCxnSpPr>
              <p:spPr>
                <a:xfrm>
                  <a:off x="3005384" y="3264941"/>
                  <a:ext cx="124893" cy="1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Connettore 2 60"/>
                <p:cNvCxnSpPr/>
                <p:nvPr/>
              </p:nvCxnSpPr>
              <p:spPr>
                <a:xfrm flipH="1">
                  <a:off x="2753684" y="3264942"/>
                  <a:ext cx="133503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sp>
        <p:nvSpPr>
          <p:cNvPr id="402" name="Rettangolo 401"/>
          <p:cNvSpPr/>
          <p:nvPr/>
        </p:nvSpPr>
        <p:spPr>
          <a:xfrm>
            <a:off x="179455" y="5142616"/>
            <a:ext cx="405880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B</a:t>
            </a:r>
          </a:p>
        </p:txBody>
      </p:sp>
      <p:sp>
        <p:nvSpPr>
          <p:cNvPr id="1214" name="Rettangolo 1213"/>
          <p:cNvSpPr/>
          <p:nvPr/>
        </p:nvSpPr>
        <p:spPr>
          <a:xfrm>
            <a:off x="172241" y="772397"/>
            <a:ext cx="420308" cy="5813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3178" dirty="0"/>
              <a:t>A</a:t>
            </a:r>
          </a:p>
        </p:txBody>
      </p:sp>
      <p:pic>
        <p:nvPicPr>
          <p:cNvPr id="43" name="Immagine 4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0886" y="5725703"/>
            <a:ext cx="6528474" cy="3907817"/>
          </a:xfrm>
          <a:prstGeom prst="rect">
            <a:avLst/>
          </a:prstGeom>
        </p:spPr>
      </p:pic>
      <p:grpSp>
        <p:nvGrpSpPr>
          <p:cNvPr id="4" name="Gruppo 3"/>
          <p:cNvGrpSpPr/>
          <p:nvPr/>
        </p:nvGrpSpPr>
        <p:grpSpPr>
          <a:xfrm>
            <a:off x="1124744" y="8871966"/>
            <a:ext cx="5318506" cy="257498"/>
            <a:chOff x="1124744" y="8871966"/>
            <a:chExt cx="5318506" cy="257498"/>
          </a:xfrm>
        </p:grpSpPr>
        <p:sp>
          <p:nvSpPr>
            <p:cNvPr id="44" name="Rettangolo 43"/>
            <p:cNvSpPr/>
            <p:nvPr/>
          </p:nvSpPr>
          <p:spPr>
            <a:xfrm>
              <a:off x="2182052" y="8871966"/>
              <a:ext cx="40348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C</a:t>
              </a:r>
              <a:endParaRPr lang="it-IT" sz="1156" dirty="0"/>
            </a:p>
          </p:txBody>
        </p:sp>
        <p:cxnSp>
          <p:nvCxnSpPr>
            <p:cNvPr id="45" name="Connettore 2 44"/>
            <p:cNvCxnSpPr/>
            <p:nvPr/>
          </p:nvCxnSpPr>
          <p:spPr>
            <a:xfrm>
              <a:off x="2627587" y="9040032"/>
              <a:ext cx="1107835" cy="12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2 45"/>
            <p:cNvCxnSpPr/>
            <p:nvPr/>
          </p:nvCxnSpPr>
          <p:spPr>
            <a:xfrm flipH="1">
              <a:off x="1124744" y="9040032"/>
              <a:ext cx="10431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Rettangolo 46"/>
            <p:cNvSpPr/>
            <p:nvPr/>
          </p:nvSpPr>
          <p:spPr>
            <a:xfrm>
              <a:off x="3834038" y="8877399"/>
              <a:ext cx="410008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SC</a:t>
              </a:r>
              <a:endParaRPr lang="it-IT" sz="1156" dirty="0"/>
            </a:p>
          </p:txBody>
        </p:sp>
        <p:cxnSp>
          <p:nvCxnSpPr>
            <p:cNvPr id="48" name="Connettore 2 47"/>
            <p:cNvCxnSpPr/>
            <p:nvPr/>
          </p:nvCxnSpPr>
          <p:spPr>
            <a:xfrm>
              <a:off x="4126104" y="9041674"/>
              <a:ext cx="160974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ttore 2 48"/>
            <p:cNvCxnSpPr/>
            <p:nvPr/>
          </p:nvCxnSpPr>
          <p:spPr>
            <a:xfrm flipH="1">
              <a:off x="3801688" y="9041675"/>
              <a:ext cx="128684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ttangolo 49"/>
            <p:cNvSpPr/>
            <p:nvPr/>
          </p:nvSpPr>
          <p:spPr>
            <a:xfrm>
              <a:off x="4686848" y="8880437"/>
              <a:ext cx="509724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MM</a:t>
              </a:r>
              <a:endParaRPr lang="it-IT" sz="1156" dirty="0"/>
            </a:p>
          </p:txBody>
        </p:sp>
        <p:cxnSp>
          <p:nvCxnSpPr>
            <p:cNvPr id="51" name="Connettore 2 50"/>
            <p:cNvCxnSpPr/>
            <p:nvPr/>
          </p:nvCxnSpPr>
          <p:spPr>
            <a:xfrm>
              <a:off x="5112230" y="9049708"/>
              <a:ext cx="49014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Connettore 2 51"/>
            <p:cNvCxnSpPr/>
            <p:nvPr/>
          </p:nvCxnSpPr>
          <p:spPr>
            <a:xfrm flipH="1">
              <a:off x="4334603" y="9044703"/>
              <a:ext cx="447794" cy="500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ttangolo 52"/>
            <p:cNvSpPr/>
            <p:nvPr/>
          </p:nvSpPr>
          <p:spPr>
            <a:xfrm>
              <a:off x="5721710" y="8880437"/>
              <a:ext cx="660795" cy="24902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156" dirty="0"/>
                <a:t>PE</a:t>
              </a:r>
              <a:endParaRPr lang="it-IT" sz="1156" dirty="0"/>
            </a:p>
          </p:txBody>
        </p:sp>
        <p:cxnSp>
          <p:nvCxnSpPr>
            <p:cNvPr id="54" name="Connettore 2 53"/>
            <p:cNvCxnSpPr/>
            <p:nvPr/>
          </p:nvCxnSpPr>
          <p:spPr>
            <a:xfrm>
              <a:off x="6183813" y="9044703"/>
              <a:ext cx="259437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ttore 2 54"/>
            <p:cNvCxnSpPr/>
            <p:nvPr/>
          </p:nvCxnSpPr>
          <p:spPr>
            <a:xfrm flipH="1">
              <a:off x="5660964" y="9044704"/>
              <a:ext cx="27732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437018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103</Words>
  <Application>Microsoft Office PowerPoint</Application>
  <PresentationFormat>A4 (21x29,7 cm)</PresentationFormat>
  <Paragraphs>13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Puntoni, Matteo</cp:lastModifiedBy>
  <cp:revision>23</cp:revision>
  <dcterms:created xsi:type="dcterms:W3CDTF">2024-04-24T16:32:13Z</dcterms:created>
  <dcterms:modified xsi:type="dcterms:W3CDTF">2025-02-11T14:11:09Z</dcterms:modified>
</cp:coreProperties>
</file>